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handoutMasterIdLst>
    <p:handoutMasterId r:id="rId7"/>
  </p:handoutMasterIdLst>
  <p:sldIdLst>
    <p:sldId id="304" r:id="rId5"/>
  </p:sldIdLst>
  <p:sldSz cx="6858000" cy="9144000" type="screen4x3"/>
  <p:notesSz cx="6742113" cy="98726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9D49F-AA6E-9F21-FC37-C929F14AF95C}" name="吳建甫" initials="吳建甫" userId="S::chienfuwu@smail.nchu.edu.tw::c5775c99-bbf3-4fcb-9699-18d78189bfe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E0511"/>
    <a:srgbClr val="3C576E"/>
    <a:srgbClr val="04AC44"/>
    <a:srgbClr val="3333FF"/>
    <a:srgbClr val="FFFFFF"/>
    <a:srgbClr val="00B050"/>
    <a:srgbClr val="BBE0E3"/>
    <a:srgbClr val="FF0080"/>
    <a:srgbClr val="333399"/>
    <a:srgbClr val="82C7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73" autoAdjust="0"/>
    <p:restoredTop sz="95964" autoAdjust="0"/>
  </p:normalViewPr>
  <p:slideViewPr>
    <p:cSldViewPr>
      <p:cViewPr varScale="1">
        <p:scale>
          <a:sx n="83" d="100"/>
          <a:sy n="83" d="100"/>
        </p:scale>
        <p:origin x="3736" y="208"/>
      </p:cViewPr>
      <p:guideLst>
        <p:guide orient="horz" pos="2880"/>
        <p:guide pos="2160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F0405E8D-78BA-46CE-9351-BD3F0736071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48638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3" name="Rectangle 1027"/>
          <p:cNvSpPr>
            <a:spLocks noGrp="1" noChangeArrowheads="1"/>
          </p:cNvSpPr>
          <p:nvPr>
            <p:ph type="dt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4" name="Rectangle 1028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982788" y="739775"/>
            <a:ext cx="2776537" cy="37036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0245" name="Rectangle 1029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8949" y="4689515"/>
            <a:ext cx="4944216" cy="44426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46" name="Rectangle 1030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7" name="Rectangle 1031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9FFBD4F-9474-4780-8DBA-462E29ED7B0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95518045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7AFA02-3A71-4EDC-B423-667874068FBD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640266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54E27CC-85E4-4496-A7F0-2E2670B20B92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25119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8CFFD98-9F5D-46B8-9754-C6A950F5FA7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68448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A7A8B3-9053-45B9-B735-E224EA3F700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2186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5FE32FF-88FC-474E-996B-A94BCDED645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750054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555867D-8AAE-4A66-A076-18178580007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95811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B8ACE5-1135-4BE0-B388-161C50BEDD8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11245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FCAD62-6D3F-45DC-B872-ADA7E085D82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9035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0ACF794-06F2-4293-9454-C61DD4CFF7E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42226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5132D4C-4246-4204-BA16-7119E5B05E5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160157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D310D11-78E9-40A8-AAC3-BBB7F94918BA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139541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2E051F03-9376-418F-B588-D0E7AFEFCA5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1F039D5-8267-E035-57A9-934DA553B7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581143"/>
              </p:ext>
            </p:extLst>
          </p:nvPr>
        </p:nvGraphicFramePr>
        <p:xfrm>
          <a:off x="296652" y="251520"/>
          <a:ext cx="6264696" cy="7083256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332148">
                  <a:extLst>
                    <a:ext uri="{9D8B030D-6E8A-4147-A177-3AD203B41FA5}">
                      <a16:colId xmlns:a16="http://schemas.microsoft.com/office/drawing/2014/main" val="447924614"/>
                    </a:ext>
                  </a:extLst>
                </a:gridCol>
                <a:gridCol w="3456384">
                  <a:extLst>
                    <a:ext uri="{9D8B030D-6E8A-4147-A177-3AD203B41FA5}">
                      <a16:colId xmlns:a16="http://schemas.microsoft.com/office/drawing/2014/main" val="1180836143"/>
                    </a:ext>
                  </a:extLst>
                </a:gridCol>
                <a:gridCol w="1476164">
                  <a:extLst>
                    <a:ext uri="{9D8B030D-6E8A-4147-A177-3AD203B41FA5}">
                      <a16:colId xmlns:a16="http://schemas.microsoft.com/office/drawing/2014/main" val="2725902909"/>
                    </a:ext>
                  </a:extLst>
                </a:gridCol>
              </a:tblGrid>
              <a:tr h="370840">
                <a:tc gridSpan="3">
                  <a:txBody>
                    <a:bodyPr/>
                    <a:lstStyle/>
                    <a:p>
                      <a:pPr algn="l"/>
                      <a:r>
                        <a:rPr lang="en-US" altLang="zh-TW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 Table S2. </a:t>
                      </a:r>
                      <a:r>
                        <a:rPr lang="en-US" altLang="zh-TW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st of primers used in this study</a:t>
                      </a:r>
                      <a:r>
                        <a:rPr lang="en-US" altLang="zh-TW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zh-TW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TW" altLang="en-US" sz="1400" b="1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TW" altLang="en-US" sz="1400" b="1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69236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b="1" dirty="0">
                          <a:latin typeface="+mj-lt"/>
                        </a:rPr>
                        <a:t>Primer name</a:t>
                      </a:r>
                      <a:endParaRPr lang="zh-TW" altLang="en-US" sz="1200" b="1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b="1" dirty="0">
                          <a:latin typeface="+mj-lt"/>
                        </a:rPr>
                        <a:t>sequence</a:t>
                      </a:r>
                      <a:endParaRPr lang="zh-TW" altLang="en-US" sz="1200" b="1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b="1" dirty="0">
                          <a:latin typeface="+mj-lt"/>
                        </a:rPr>
                        <a:t>purpose</a:t>
                      </a:r>
                      <a:endParaRPr lang="zh-TW" altLang="en-US" sz="1200" b="1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49831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indent="0"/>
                      <a:r>
                        <a:rPr lang="en-US" altLang="zh-TW" sz="1200" dirty="0">
                          <a:latin typeface="+mj-lt"/>
                        </a:rPr>
                        <a:t> ORF1-F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GGCTTACCCCTTACTTATTTGTG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10">
                  <a:txBody>
                    <a:bodyPr/>
                    <a:lstStyle/>
                    <a:p>
                      <a:pPr algn="l"/>
                      <a:r>
                        <a:rPr lang="en-US" altLang="zh-TW" sz="1200" dirty="0">
                          <a:latin typeface="+mj-lt"/>
                        </a:rPr>
                        <a:t>Plasmid construction for probes </a:t>
                      </a:r>
                    </a:p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&amp; </a:t>
                      </a:r>
                    </a:p>
                    <a:p>
                      <a:pPr algn="l"/>
                      <a:r>
                        <a:rPr lang="en-US" altLang="zh-TW" sz="1200" dirty="0">
                          <a:latin typeface="+mj-lt"/>
                        </a:rPr>
                        <a:t>DIG DNA probe synthesis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487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 ORF1-R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GGTAATAGTCCACCAAATGACG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409493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 ORF2-F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ATGGCAACTGTCTTCGATAAC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91793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 ORF2-R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CTACAATTTCTTGATGGAGCG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438532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 ORF3-F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ATGTTTAGCCACCCTTTTGTC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109592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 ORF3-R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AGACATGCTGGAAGGAAAACC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09991430"/>
                  </a:ext>
                </a:extLst>
              </a:tr>
              <a:tr h="428456"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 ORF4-F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ATGTCTGACCTGGTTGGTG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28691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 ORF4-R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TCATGATTTCCAAGTCTGCAC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17183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 ORF5-F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ATGAACGCTCTGCCGCCG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493614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 ORF5-R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TCAAACCAATGTGAAATAATAG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6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28474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ORF4-F-</a:t>
                      </a:r>
                      <a:r>
                        <a:rPr lang="en-US" altLang="zh-TW" sz="1200" i="1" dirty="0">
                          <a:latin typeface="+mj-lt"/>
                        </a:rPr>
                        <a:t>Nde</a:t>
                      </a:r>
                      <a:r>
                        <a:rPr lang="en-US" altLang="zh-TW" sz="1200" i="0" dirty="0">
                          <a:latin typeface="+mj-lt"/>
                        </a:rPr>
                        <a:t>I</a:t>
                      </a:r>
                      <a:endParaRPr lang="zh-TW" altLang="en-US" sz="1200" i="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zh-TW" sz="12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’-TATCATATGTCTGACCTGGTTGGTGAC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Protein expression plasmid construction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44593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ORF4-R-</a:t>
                      </a:r>
                      <a:r>
                        <a:rPr lang="en-US" altLang="zh-TW" sz="1200" i="1" dirty="0">
                          <a:latin typeface="+mj-lt"/>
                        </a:rPr>
                        <a:t>Xho</a:t>
                      </a:r>
                      <a:r>
                        <a:rPr lang="en-US" altLang="zh-TW" sz="1200" dirty="0">
                          <a:latin typeface="+mj-lt"/>
                        </a:rPr>
                        <a:t>I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zh-TW" sz="12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’-AAACTCGAGTGATTTCCAAGTCTGCACAAATC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277947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ORF2-R2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AGCTTTGATCGAGCCTTGCCAATCTC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RLM-RACE for sgRNA detection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35249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ORF2-R3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ATAGCTTGGAGCGGGCTAATGG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103127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ORF4-F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ATGTCTGACCTGGTTGGTG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viral genome RT-PCR detection for virus particle purification 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78639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+mj-lt"/>
                        </a:rPr>
                        <a:t>ORF4-R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200" dirty="0">
                          <a:latin typeface="+mj-lt"/>
                        </a:rPr>
                        <a:t>5’-TCATGATTTCCAAGTCTGCAC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156192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06187623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文件" ma:contentTypeID="0x0101007E2FD972D4BEA54BA4598308043A68E5" ma:contentTypeVersion="15" ma:contentTypeDescription="建立新的文件。" ma:contentTypeScope="" ma:versionID="a8220bdea2b7e7a673e49e11bde4d37a">
  <xsd:schema xmlns:xsd="http://www.w3.org/2001/XMLSchema" xmlns:xs="http://www.w3.org/2001/XMLSchema" xmlns:p="http://schemas.microsoft.com/office/2006/metadata/properties" xmlns:ns3="48771fd5-fdbd-41d5-a635-61c877e51ed8" targetNamespace="http://schemas.microsoft.com/office/2006/metadata/properties" ma:root="true" ma:fieldsID="43f6d274064a590dd4c7dc18eb5ad241" ns3:_="">
    <xsd:import namespace="48771fd5-fdbd-41d5-a635-61c877e51ed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771fd5-fdbd-41d5-a635-61c877e51ed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1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內容類型"/>
        <xsd:element ref="dc:title" minOccurs="0" maxOccurs="1" ma:index="4" ma:displayName="標題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8771fd5-fdbd-41d5-a635-61c877e51ed8" xsi:nil="true"/>
  </documentManagement>
</p:properties>
</file>

<file path=customXml/itemProps1.xml><?xml version="1.0" encoding="utf-8"?>
<ds:datastoreItem xmlns:ds="http://schemas.openxmlformats.org/officeDocument/2006/customXml" ds:itemID="{07D4AA48-083E-4379-89A1-F75D79A20FC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8771fd5-fdbd-41d5-a635-61c877e51ed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BB41457-EEA7-4D1C-80C7-C64600237B1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0A4D93D-CB7A-4046-B8F0-734EB4DA984F}">
  <ds:schemaRefs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48771fd5-fdbd-41d5-a635-61c877e51ed8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3137</TotalTime>
  <Words>115</Words>
  <Application>Microsoft Macintosh PowerPoint</Application>
  <PresentationFormat>画面に合わせる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新しいプレゼンテーション</vt:lpstr>
      <vt:lpstr>PowerPoint プレゼンテーション</vt:lpstr>
    </vt:vector>
  </TitlesOfParts>
  <Company>青木 菜々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template</dc:title>
  <dc:creator>Chien-Fu Wu</dc:creator>
  <cp:lastModifiedBy>KOMATSU Ken</cp:lastModifiedBy>
  <cp:revision>1146</cp:revision>
  <cp:lastPrinted>2021-04-12T04:03:22Z</cp:lastPrinted>
  <dcterms:created xsi:type="dcterms:W3CDTF">2010-08-07T07:11:10Z</dcterms:created>
  <dcterms:modified xsi:type="dcterms:W3CDTF">2024-09-15T07:44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E2FD972D4BEA54BA4598308043A68E5</vt:lpwstr>
  </property>
</Properties>
</file>